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9" r:id="rId2"/>
    <p:sldId id="262" r:id="rId3"/>
    <p:sldId id="260" r:id="rId4"/>
    <p:sldId id="261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4" d="100"/>
          <a:sy n="64" d="100"/>
        </p:scale>
        <p:origin x="134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&#26032;&#24314;%20Microsoft%20Excel%20&#24037;&#20316;&#3492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king%20stress%20cadmium%20stress\qRT-PCR%20data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126156513428061"/>
          <c:y val="0.107497078994158"/>
          <c:w val="0.78518249966955556"/>
          <c:h val="0.73496263148245344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2">
                  <a:lumMod val="50000"/>
                </a:schemeClr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Sheet1!$H$4:$H$84</c:f>
              <c:numCache>
                <c:formatCode>General</c:formatCode>
                <c:ptCount val="81"/>
                <c:pt idx="0">
                  <c:v>2.1898351379605356E-3</c:v>
                </c:pt>
                <c:pt idx="1">
                  <c:v>1.2969765874459405</c:v>
                </c:pt>
                <c:pt idx="2">
                  <c:v>0.942810473172352</c:v>
                </c:pt>
                <c:pt idx="3">
                  <c:v>0.81055679936049563</c:v>
                </c:pt>
                <c:pt idx="4">
                  <c:v>-0.10752628071431987</c:v>
                </c:pt>
                <c:pt idx="5">
                  <c:v>-0.33619096358523443</c:v>
                </c:pt>
                <c:pt idx="6">
                  <c:v>-0.23837405534146605</c:v>
                </c:pt>
                <c:pt idx="7">
                  <c:v>1.7379906072169333</c:v>
                </c:pt>
                <c:pt idx="8">
                  <c:v>0.81727282345002994</c:v>
                </c:pt>
                <c:pt idx="9">
                  <c:v>1.481333101896859E-2</c:v>
                </c:pt>
                <c:pt idx="10">
                  <c:v>1.1417315188268469E-2</c:v>
                </c:pt>
                <c:pt idx="11">
                  <c:v>-1.4761328578543027</c:v>
                </c:pt>
                <c:pt idx="12">
                  <c:v>-1.7534856038559494</c:v>
                </c:pt>
                <c:pt idx="13">
                  <c:v>-0.92485989243658218</c:v>
                </c:pt>
                <c:pt idx="14">
                  <c:v>-1.6306813453485234</c:v>
                </c:pt>
                <c:pt idx="15">
                  <c:v>-2.0030701471204404</c:v>
                </c:pt>
                <c:pt idx="16">
                  <c:v>4.4423857026769393E-3</c:v>
                </c:pt>
                <c:pt idx="17">
                  <c:v>1.0449939170675753</c:v>
                </c:pt>
                <c:pt idx="18">
                  <c:v>1.1681245634881061</c:v>
                </c:pt>
                <c:pt idx="19">
                  <c:v>0.80277685657486186</c:v>
                </c:pt>
                <c:pt idx="20">
                  <c:v>0.93986760190058438</c:v>
                </c:pt>
                <c:pt idx="21">
                  <c:v>0.67410526991490494</c:v>
                </c:pt>
                <c:pt idx="22">
                  <c:v>3.1077843235168762E-3</c:v>
                </c:pt>
                <c:pt idx="23">
                  <c:v>-0.14498837466297923</c:v>
                </c:pt>
                <c:pt idx="24">
                  <c:v>8.3338931594058085E-2</c:v>
                </c:pt>
                <c:pt idx="25">
                  <c:v>-8.8258133128588975E-2</c:v>
                </c:pt>
                <c:pt idx="26">
                  <c:v>0.47557920694192946</c:v>
                </c:pt>
                <c:pt idx="27">
                  <c:v>0.13200856958851256</c:v>
                </c:pt>
                <c:pt idx="28">
                  <c:v>1.8057610681321461</c:v>
                </c:pt>
                <c:pt idx="29">
                  <c:v>0.92347631165207988</c:v>
                </c:pt>
                <c:pt idx="30">
                  <c:v>2.1184774621711551</c:v>
                </c:pt>
                <c:pt idx="31">
                  <c:v>2.8213491712283618</c:v>
                </c:pt>
                <c:pt idx="32">
                  <c:v>2.0890052996061144</c:v>
                </c:pt>
                <c:pt idx="33">
                  <c:v>1.625588441574442E-3</c:v>
                </c:pt>
                <c:pt idx="34">
                  <c:v>0.31580597898521878</c:v>
                </c:pt>
                <c:pt idx="35">
                  <c:v>0.34077873638760514</c:v>
                </c:pt>
                <c:pt idx="36">
                  <c:v>1.7386364030297468</c:v>
                </c:pt>
                <c:pt idx="37">
                  <c:v>1.7830253098622673</c:v>
                </c:pt>
                <c:pt idx="38">
                  <c:v>1.6925709318595037</c:v>
                </c:pt>
                <c:pt idx="39">
                  <c:v>3.4252197547784756E-3</c:v>
                </c:pt>
                <c:pt idx="40">
                  <c:v>-0.55272613973238083</c:v>
                </c:pt>
                <c:pt idx="41">
                  <c:v>-0.25436712637068204</c:v>
                </c:pt>
                <c:pt idx="42">
                  <c:v>-1.4621647392941233</c:v>
                </c:pt>
                <c:pt idx="43">
                  <c:v>-1.771465232867468</c:v>
                </c:pt>
                <c:pt idx="44">
                  <c:v>-2.1091005231804081</c:v>
                </c:pt>
                <c:pt idx="45">
                  <c:v>6.0528734560438826E-3</c:v>
                </c:pt>
                <c:pt idx="46">
                  <c:v>1.5219309186057717</c:v>
                </c:pt>
                <c:pt idx="47">
                  <c:v>0.87450965545595272</c:v>
                </c:pt>
                <c:pt idx="48">
                  <c:v>-0.5566274342872638</c:v>
                </c:pt>
                <c:pt idx="49">
                  <c:v>-0.52215996937683828</c:v>
                </c:pt>
                <c:pt idx="50">
                  <c:v>-0.96384083677700749</c:v>
                </c:pt>
                <c:pt idx="51">
                  <c:v>3.2952875488154411E-3</c:v>
                </c:pt>
                <c:pt idx="52">
                  <c:v>0.17232754205909157</c:v>
                </c:pt>
                <c:pt idx="53">
                  <c:v>0.42174768197083218</c:v>
                </c:pt>
                <c:pt idx="54">
                  <c:v>-8.2306934928708123E-2</c:v>
                </c:pt>
                <c:pt idx="55">
                  <c:v>-0.30775227791139714</c:v>
                </c:pt>
                <c:pt idx="56">
                  <c:v>-0.18854305729673565</c:v>
                </c:pt>
                <c:pt idx="57">
                  <c:v>-0.18162658046995936</c:v>
                </c:pt>
                <c:pt idx="58">
                  <c:v>0.61225169966203474</c:v>
                </c:pt>
                <c:pt idx="59">
                  <c:v>-0.26777468738465326</c:v>
                </c:pt>
                <c:pt idx="60">
                  <c:v>1.2584820283323706</c:v>
                </c:pt>
                <c:pt idx="61">
                  <c:v>-3.737861586131036E-2</c:v>
                </c:pt>
                <c:pt idx="62">
                  <c:v>1.0647699467934038E-3</c:v>
                </c:pt>
                <c:pt idx="63">
                  <c:v>-0.40628713619806855</c:v>
                </c:pt>
                <c:pt idx="64">
                  <c:v>-0.27475249671339874</c:v>
                </c:pt>
                <c:pt idx="65">
                  <c:v>-0.76628078191785298</c:v>
                </c:pt>
                <c:pt idx="66">
                  <c:v>-0.61479075204533218</c:v>
                </c:pt>
                <c:pt idx="67">
                  <c:v>-0.35471281528245041</c:v>
                </c:pt>
                <c:pt idx="68">
                  <c:v>8.6780222911929839E-4</c:v>
                </c:pt>
                <c:pt idx="69">
                  <c:v>0.48379406362930549</c:v>
                </c:pt>
                <c:pt idx="70">
                  <c:v>0.38784277672315615</c:v>
                </c:pt>
                <c:pt idx="71">
                  <c:v>-0.13524863432701964</c:v>
                </c:pt>
                <c:pt idx="72">
                  <c:v>-0.1209150658666546</c:v>
                </c:pt>
                <c:pt idx="73">
                  <c:v>-0.46496427020068226</c:v>
                </c:pt>
                <c:pt idx="74">
                  <c:v>-6.4552786076868627E-4</c:v>
                </c:pt>
                <c:pt idx="75">
                  <c:v>0.27732123279637838</c:v>
                </c:pt>
                <c:pt idx="76">
                  <c:v>0.49921660670843476</c:v>
                </c:pt>
                <c:pt idx="77">
                  <c:v>1.2322067334715241</c:v>
                </c:pt>
                <c:pt idx="78">
                  <c:v>1.3910874510540541</c:v>
                </c:pt>
                <c:pt idx="79">
                  <c:v>3.3070512120784664E-4</c:v>
                </c:pt>
                <c:pt idx="80">
                  <c:v>-2.4673330915929403</c:v>
                </c:pt>
              </c:numCache>
            </c:numRef>
          </c:xVal>
          <c:yVal>
            <c:numRef>
              <c:f>Sheet1!$I$4:$I$84</c:f>
              <c:numCache>
                <c:formatCode>General</c:formatCode>
                <c:ptCount val="81"/>
                <c:pt idx="0">
                  <c:v>-0.95860731484177497</c:v>
                </c:pt>
                <c:pt idx="1">
                  <c:v>0.77451696572854956</c:v>
                </c:pt>
                <c:pt idx="2">
                  <c:v>0.40767410922931852</c:v>
                </c:pt>
                <c:pt idx="3">
                  <c:v>0.27646180417324412</c:v>
                </c:pt>
                <c:pt idx="4">
                  <c:v>-0.95860731484177497</c:v>
                </c:pt>
                <c:pt idx="5">
                  <c:v>-1.2730012720637376</c:v>
                </c:pt>
                <c:pt idx="6">
                  <c:v>-0.63202321470540568</c:v>
                </c:pt>
                <c:pt idx="7">
                  <c:v>0.69548167649019743</c:v>
                </c:pt>
                <c:pt idx="8">
                  <c:v>0.63481302161301911</c:v>
                </c:pt>
                <c:pt idx="9">
                  <c:v>-0.80502339678394508</c:v>
                </c:pt>
                <c:pt idx="10">
                  <c:v>2.5693426923578513</c:v>
                </c:pt>
                <c:pt idx="11">
                  <c:v>1.2896632607781966</c:v>
                </c:pt>
                <c:pt idx="12">
                  <c:v>0.94151143263440307</c:v>
                </c:pt>
                <c:pt idx="13">
                  <c:v>1.65931391573872</c:v>
                </c:pt>
                <c:pt idx="14">
                  <c:v>1.312459457444763</c:v>
                </c:pt>
                <c:pt idx="15">
                  <c:v>0.83122969386706336</c:v>
                </c:pt>
                <c:pt idx="16">
                  <c:v>0.97833271405896571</c:v>
                </c:pt>
                <c:pt idx="17">
                  <c:v>2.0563966072973052</c:v>
                </c:pt>
                <c:pt idx="18">
                  <c:v>2.1073626244693791</c:v>
                </c:pt>
                <c:pt idx="19">
                  <c:v>1.8905886677054873</c:v>
                </c:pt>
                <c:pt idx="20">
                  <c:v>1.9304395947667001</c:v>
                </c:pt>
                <c:pt idx="21">
                  <c:v>1.764475027434409</c:v>
                </c:pt>
                <c:pt idx="22">
                  <c:v>2.5305865264770171E-2</c:v>
                </c:pt>
                <c:pt idx="23">
                  <c:v>-0.53263858256949381</c:v>
                </c:pt>
                <c:pt idx="24">
                  <c:v>-0.24667233334138844</c:v>
                </c:pt>
                <c:pt idx="25">
                  <c:v>1.0669467896306131</c:v>
                </c:pt>
                <c:pt idx="26">
                  <c:v>2.6143346583354297</c:v>
                </c:pt>
                <c:pt idx="27">
                  <c:v>1.935473676398817</c:v>
                </c:pt>
                <c:pt idx="28">
                  <c:v>0.36361197989214433</c:v>
                </c:pt>
                <c:pt idx="29">
                  <c:v>-0.27029537868781278</c:v>
                </c:pt>
                <c:pt idx="30">
                  <c:v>0.11947584090679779</c:v>
                </c:pt>
                <c:pt idx="31">
                  <c:v>1.2194098652499448</c:v>
                </c:pt>
                <c:pt idx="32">
                  <c:v>0.41664050733828095</c:v>
                </c:pt>
                <c:pt idx="33">
                  <c:v>1.1295287738587763</c:v>
                </c:pt>
                <c:pt idx="34">
                  <c:v>0.97158506518541743</c:v>
                </c:pt>
                <c:pt idx="35">
                  <c:v>0.77158748088125539</c:v>
                </c:pt>
                <c:pt idx="36">
                  <c:v>2.2920122662363456</c:v>
                </c:pt>
                <c:pt idx="37">
                  <c:v>2.5415251617645289</c:v>
                </c:pt>
                <c:pt idx="38">
                  <c:v>2.3557898327778863</c:v>
                </c:pt>
                <c:pt idx="39">
                  <c:v>0.90543606718912339</c:v>
                </c:pt>
                <c:pt idx="40">
                  <c:v>0.61207711208548643</c:v>
                </c:pt>
                <c:pt idx="41">
                  <c:v>0.8221680793680175</c:v>
                </c:pt>
                <c:pt idx="42">
                  <c:v>8.3980128929393563E-2</c:v>
                </c:pt>
                <c:pt idx="43">
                  <c:v>-0.22670125241076849</c:v>
                </c:pt>
                <c:pt idx="44">
                  <c:v>-0.69897000433601886</c:v>
                </c:pt>
                <c:pt idx="45">
                  <c:v>-8.7739243075051019E-3</c:v>
                </c:pt>
                <c:pt idx="46">
                  <c:v>1.6110857334148727</c:v>
                </c:pt>
                <c:pt idx="47">
                  <c:v>1.1565491513317814</c:v>
                </c:pt>
                <c:pt idx="48">
                  <c:v>-2.6872146400301312E-2</c:v>
                </c:pt>
                <c:pt idx="49">
                  <c:v>0.24138043414761182</c:v>
                </c:pt>
                <c:pt idx="50">
                  <c:v>-0.86433739799992693</c:v>
                </c:pt>
                <c:pt idx="51">
                  <c:v>0.43985879260071981</c:v>
                </c:pt>
                <c:pt idx="52">
                  <c:v>0.60923857595508579</c:v>
                </c:pt>
                <c:pt idx="53">
                  <c:v>1.1287222843384268</c:v>
                </c:pt>
                <c:pt idx="54">
                  <c:v>0.53444918887761572</c:v>
                </c:pt>
                <c:pt idx="55">
                  <c:v>-2.3802914672624766E-2</c:v>
                </c:pt>
                <c:pt idx="56">
                  <c:v>0.18752072083646307</c:v>
                </c:pt>
                <c:pt idx="57">
                  <c:v>-0.63202321470540568</c:v>
                </c:pt>
                <c:pt idx="58">
                  <c:v>-0.6137983945992066</c:v>
                </c:pt>
                <c:pt idx="59">
                  <c:v>-1.1549019599857433</c:v>
                </c:pt>
                <c:pt idx="60">
                  <c:v>0.24879037757538577</c:v>
                </c:pt>
                <c:pt idx="61">
                  <c:v>-0.50399340111996371</c:v>
                </c:pt>
                <c:pt idx="62">
                  <c:v>1.2435341018320618</c:v>
                </c:pt>
                <c:pt idx="63">
                  <c:v>0.85146219499453957</c:v>
                </c:pt>
                <c:pt idx="64">
                  <c:v>1.0618293072946992</c:v>
                </c:pt>
                <c:pt idx="65">
                  <c:v>-0.95860731484177497</c:v>
                </c:pt>
                <c:pt idx="66">
                  <c:v>0.10380372095595679</c:v>
                </c:pt>
                <c:pt idx="67">
                  <c:v>-0.79588001734407521</c:v>
                </c:pt>
                <c:pt idx="68">
                  <c:v>1.7388069746202555</c:v>
                </c:pt>
                <c:pt idx="69">
                  <c:v>2.3575155886150969</c:v>
                </c:pt>
                <c:pt idx="70">
                  <c:v>2.2506557910981657</c:v>
                </c:pt>
                <c:pt idx="71">
                  <c:v>1.4627472897398472</c:v>
                </c:pt>
                <c:pt idx="72">
                  <c:v>1.4963298893052723</c:v>
                </c:pt>
                <c:pt idx="73">
                  <c:v>1.3370597263205246</c:v>
                </c:pt>
                <c:pt idx="74">
                  <c:v>-1.4771212547196624</c:v>
                </c:pt>
                <c:pt idx="75">
                  <c:v>-0.3010299956639812</c:v>
                </c:pt>
                <c:pt idx="76">
                  <c:v>0.12493873660829993</c:v>
                </c:pt>
                <c:pt idx="77">
                  <c:v>1.703333929878037E-2</c:v>
                </c:pt>
                <c:pt idx="78">
                  <c:v>0.77427359532044182</c:v>
                </c:pt>
                <c:pt idx="79">
                  <c:v>1.7273514489293016</c:v>
                </c:pt>
                <c:pt idx="80">
                  <c:v>-1.69897000433601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8D2-4ED1-A401-3645E40D78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47091695"/>
        <c:axId val="1547100431"/>
      </c:scatterChart>
      <c:valAx>
        <c:axId val="154709169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b="1" i="0" u="none" strike="noStrike" baseline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NA-Seq (Log</a:t>
                </a:r>
                <a:r>
                  <a:rPr lang="en-US" altLang="zh-CN" sz="900" b="1" i="0" u="none" strike="noStrike" baseline="-2500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r>
                  <a:rPr lang="en-US" altLang="zh-CN" sz="900" b="1" i="0" u="none" strike="noStrike" baseline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TPM)</a:t>
                </a:r>
                <a:r>
                  <a:rPr lang="en-US" altLang="zh-CN" sz="900" b="1" i="0" u="none" strike="noStrike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900" b="1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7504208704550532"/>
              <c:y val="0.930053534264196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47100431"/>
        <c:crossesAt val="-3"/>
        <c:crossBetween val="midCat"/>
      </c:valAx>
      <c:valAx>
        <c:axId val="1547100431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b="1" i="0" u="none" strike="noStrike" baseline="0" dirty="0" err="1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RT</a:t>
                </a:r>
                <a:r>
                  <a:rPr lang="en-US" altLang="zh-CN" sz="900" b="1" i="0" u="none" strike="noStrike" baseline="0" dirty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CR (Log</a:t>
                </a:r>
                <a:r>
                  <a:rPr lang="en-US" altLang="zh-CN" sz="900" b="1" i="0" u="none" strike="noStrike" baseline="-25000" dirty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r>
                  <a:rPr lang="en-US" altLang="zh-CN" sz="900" b="1" i="0" u="none" strike="noStrike" baseline="0" dirty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expression level)</a:t>
                </a:r>
                <a:r>
                  <a:rPr lang="en-US" altLang="zh-CN" sz="900" b="1" i="0" u="none" strike="noStrike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8.1154910854496734E-2"/>
              <c:y val="0.223049324585186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47091695"/>
        <c:crossesAt val="-3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182950191570876E-2"/>
          <c:y val="3.907013888888889E-2"/>
          <c:w val="0.76513984674329505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234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236:$X$236</c:f>
                <c:numCache>
                  <c:formatCode>General</c:formatCode>
                  <c:ptCount val="6"/>
                  <c:pt idx="0">
                    <c:v>0.19955043759277052</c:v>
                  </c:pt>
                  <c:pt idx="1">
                    <c:v>2.3339217255377269</c:v>
                  </c:pt>
                  <c:pt idx="2">
                    <c:v>0.75384255612534323</c:v>
                  </c:pt>
                  <c:pt idx="3">
                    <c:v>6.3873164875958607E-2</c:v>
                  </c:pt>
                  <c:pt idx="4">
                    <c:v>1.9819982995417776E-2</c:v>
                  </c:pt>
                  <c:pt idx="5">
                    <c:v>2.7684244009829429E-2</c:v>
                  </c:pt>
                </c:numCache>
              </c:numRef>
            </c:plus>
            <c:minus>
              <c:numRef>
                <c:f>Sheet1!$S$236:$X$236</c:f>
                <c:numCache>
                  <c:formatCode>General</c:formatCode>
                  <c:ptCount val="6"/>
                  <c:pt idx="0">
                    <c:v>0.19955043759277052</c:v>
                  </c:pt>
                  <c:pt idx="1">
                    <c:v>2.3339217255377269</c:v>
                  </c:pt>
                  <c:pt idx="2">
                    <c:v>0.75384255612534323</c:v>
                  </c:pt>
                  <c:pt idx="3">
                    <c:v>6.3873164875958607E-2</c:v>
                  </c:pt>
                  <c:pt idx="4">
                    <c:v>1.9819982995417776E-2</c:v>
                  </c:pt>
                  <c:pt idx="5">
                    <c:v>2.7684244009829429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233:$X$233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234:$X$234</c:f>
              <c:numCache>
                <c:formatCode>General</c:formatCode>
                <c:ptCount val="6"/>
                <c:pt idx="0">
                  <c:v>1.0140348325332271</c:v>
                </c:pt>
                <c:pt idx="1">
                  <c:v>33.260664274808036</c:v>
                </c:pt>
                <c:pt idx="2">
                  <c:v>7.4904801154225238</c:v>
                </c:pt>
                <c:pt idx="3">
                  <c:v>0.27757002576190276</c:v>
                </c:pt>
                <c:pt idx="4">
                  <c:v>0.30049692390588711</c:v>
                </c:pt>
                <c:pt idx="5">
                  <c:v>0.108682385730675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645-4EFD-AF83-11B2E0C8C9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644144"/>
        <c:axId val="1734628752"/>
      </c:barChart>
      <c:lineChart>
        <c:grouping val="standard"/>
        <c:varyColors val="0"/>
        <c:ser>
          <c:idx val="1"/>
          <c:order val="1"/>
          <c:tx>
            <c:strRef>
              <c:f>Sheet1!$R$235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233:$X$233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235:$X$235</c:f>
              <c:numCache>
                <c:formatCode>General</c:formatCode>
                <c:ptCount val="6"/>
                <c:pt idx="0">
                  <c:v>0.98000000000000009</c:v>
                </c:pt>
                <c:pt idx="1">
                  <c:v>40.840000000000003</c:v>
                </c:pt>
                <c:pt idx="2">
                  <c:v>14.340000000000002</c:v>
                </c:pt>
                <c:pt idx="3">
                  <c:v>0.94000000000000006</c:v>
                </c:pt>
                <c:pt idx="4">
                  <c:v>1.7433333333333334</c:v>
                </c:pt>
                <c:pt idx="5">
                  <c:v>0.136666666666666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645-4EFD-AF83-11B2E0C8C9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630000"/>
        <c:axId val="1734633328"/>
      </c:lineChart>
      <c:catAx>
        <c:axId val="1734644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28752"/>
        <c:crosses val="autoZero"/>
        <c:auto val="1"/>
        <c:lblAlgn val="ctr"/>
        <c:lblOffset val="100"/>
        <c:noMultiLvlLbl val="0"/>
      </c:catAx>
      <c:valAx>
        <c:axId val="173462875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44144"/>
        <c:crosses val="autoZero"/>
        <c:crossBetween val="between"/>
      </c:valAx>
      <c:valAx>
        <c:axId val="1734633328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30000"/>
        <c:crosses val="max"/>
        <c:crossBetween val="between"/>
      </c:valAx>
      <c:catAx>
        <c:axId val="173463000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3332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34770114942528"/>
          <c:y val="3.907013888888889E-2"/>
          <c:w val="0.77730459770114946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257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259:$X$259</c:f>
                <c:numCache>
                  <c:formatCode>General</c:formatCode>
                  <c:ptCount val="6"/>
                  <c:pt idx="0">
                    <c:v>9.5522664653644826E-2</c:v>
                  </c:pt>
                  <c:pt idx="1">
                    <c:v>0.10480335564912441</c:v>
                  </c:pt>
                  <c:pt idx="2">
                    <c:v>0.32485152958321567</c:v>
                  </c:pt>
                  <c:pt idx="3">
                    <c:v>6.7172170058134431E-2</c:v>
                  </c:pt>
                  <c:pt idx="4">
                    <c:v>4.7073085743036404E-2</c:v>
                  </c:pt>
                  <c:pt idx="5">
                    <c:v>0.11713546773474776</c:v>
                  </c:pt>
                </c:numCache>
              </c:numRef>
            </c:plus>
            <c:minus>
              <c:numRef>
                <c:f>Sheet1!$S$259:$X$259</c:f>
                <c:numCache>
                  <c:formatCode>General</c:formatCode>
                  <c:ptCount val="6"/>
                  <c:pt idx="0">
                    <c:v>9.5522664653644826E-2</c:v>
                  </c:pt>
                  <c:pt idx="1">
                    <c:v>0.10480335564912441</c:v>
                  </c:pt>
                  <c:pt idx="2">
                    <c:v>0.32485152958321567</c:v>
                  </c:pt>
                  <c:pt idx="3">
                    <c:v>6.7172170058134431E-2</c:v>
                  </c:pt>
                  <c:pt idx="4">
                    <c:v>4.7073085743036404E-2</c:v>
                  </c:pt>
                  <c:pt idx="5">
                    <c:v>0.1171354677347477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256:$X$256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257:$X$257</c:f>
              <c:numCache>
                <c:formatCode>General</c:formatCode>
                <c:ptCount val="6"/>
                <c:pt idx="0">
                  <c:v>1.007616539376585</c:v>
                </c:pt>
                <c:pt idx="1">
                  <c:v>1.4870567479463919</c:v>
                </c:pt>
                <c:pt idx="2">
                  <c:v>2.6408740066946605</c:v>
                </c:pt>
                <c:pt idx="3">
                  <c:v>0.82735722745290541</c:v>
                </c:pt>
                <c:pt idx="4">
                  <c:v>0.49232027567695619</c:v>
                </c:pt>
                <c:pt idx="5">
                  <c:v>0.647823864825349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C8-4286-B880-2A5086908B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600880"/>
        <c:axId val="1734619184"/>
      </c:barChart>
      <c:lineChart>
        <c:grouping val="standard"/>
        <c:varyColors val="0"/>
        <c:ser>
          <c:idx val="1"/>
          <c:order val="1"/>
          <c:tx>
            <c:strRef>
              <c:f>Sheet1!$R$258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256:$X$256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258:$X$258</c:f>
              <c:numCache>
                <c:formatCode>General</c:formatCode>
                <c:ptCount val="6"/>
                <c:pt idx="0">
                  <c:v>2.7533333333333334</c:v>
                </c:pt>
                <c:pt idx="1">
                  <c:v>4.0666666666666664</c:v>
                </c:pt>
                <c:pt idx="2">
                  <c:v>13.450000000000001</c:v>
                </c:pt>
                <c:pt idx="3">
                  <c:v>3.4233333333333333</c:v>
                </c:pt>
                <c:pt idx="4">
                  <c:v>0.94666666666666666</c:v>
                </c:pt>
                <c:pt idx="5">
                  <c:v>1.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FC8-4286-B880-2A5086908B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625424"/>
        <c:axId val="1734621680"/>
      </c:lineChart>
      <c:catAx>
        <c:axId val="1734600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19184"/>
        <c:crosses val="autoZero"/>
        <c:auto val="1"/>
        <c:lblAlgn val="ctr"/>
        <c:lblOffset val="100"/>
        <c:noMultiLvlLbl val="0"/>
      </c:catAx>
      <c:valAx>
        <c:axId val="173461918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00880"/>
        <c:crosses val="autoZero"/>
        <c:crossBetween val="between"/>
      </c:valAx>
      <c:valAx>
        <c:axId val="1734621680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25424"/>
        <c:crosses val="max"/>
        <c:crossBetween val="between"/>
      </c:valAx>
      <c:catAx>
        <c:axId val="17346254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2168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182950191570876E-2"/>
          <c:y val="3.907013888888889E-2"/>
          <c:w val="0.76513984674329505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326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328:$X$328</c:f>
                <c:numCache>
                  <c:formatCode>General</c:formatCode>
                  <c:ptCount val="6"/>
                  <c:pt idx="0">
                    <c:v>0.18153614180963049</c:v>
                  </c:pt>
                  <c:pt idx="1">
                    <c:v>7.867112991857643E-2</c:v>
                  </c:pt>
                  <c:pt idx="2">
                    <c:v>0.86648034267678797</c:v>
                  </c:pt>
                  <c:pt idx="3">
                    <c:v>0.13693910245674121</c:v>
                  </c:pt>
                  <c:pt idx="4">
                    <c:v>2.7205566670308921</c:v>
                  </c:pt>
                  <c:pt idx="5">
                    <c:v>0.7653288484209404</c:v>
                  </c:pt>
                </c:numCache>
              </c:numRef>
            </c:plus>
            <c:minus>
              <c:numRef>
                <c:f>Sheet1!$S$328:$X$328</c:f>
                <c:numCache>
                  <c:formatCode>General</c:formatCode>
                  <c:ptCount val="6"/>
                  <c:pt idx="0">
                    <c:v>0.18153614180963049</c:v>
                  </c:pt>
                  <c:pt idx="1">
                    <c:v>7.867112991857643E-2</c:v>
                  </c:pt>
                  <c:pt idx="2">
                    <c:v>0.86648034267678797</c:v>
                  </c:pt>
                  <c:pt idx="3">
                    <c:v>0.13693910245674121</c:v>
                  </c:pt>
                  <c:pt idx="4">
                    <c:v>2.7205566670308921</c:v>
                  </c:pt>
                  <c:pt idx="5">
                    <c:v>0.765328848420940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325:$X$325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326:$X$326</c:f>
              <c:numCache>
                <c:formatCode>General</c:formatCode>
                <c:ptCount val="6"/>
                <c:pt idx="0">
                  <c:v>1.0056951771035247</c:v>
                </c:pt>
                <c:pt idx="1">
                  <c:v>0.65822355462928217</c:v>
                </c:pt>
                <c:pt idx="2">
                  <c:v>4.0949791953932113</c:v>
                </c:pt>
                <c:pt idx="3">
                  <c:v>0.53979059403736318</c:v>
                </c:pt>
                <c:pt idx="4">
                  <c:v>18.133516354810627</c:v>
                </c:pt>
                <c:pt idx="5">
                  <c:v>0.917532347376225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6B-4ADA-B1B2-83963F0246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699472"/>
        <c:axId val="1734682000"/>
      </c:barChart>
      <c:lineChart>
        <c:grouping val="standard"/>
        <c:varyColors val="0"/>
        <c:ser>
          <c:idx val="1"/>
          <c:order val="1"/>
          <c:tx>
            <c:strRef>
              <c:f>Sheet1!$R$327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325:$X$325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327:$X$327</c:f>
              <c:numCache>
                <c:formatCode>General</c:formatCode>
                <c:ptCount val="6"/>
                <c:pt idx="0">
                  <c:v>0</c:v>
                </c:pt>
                <c:pt idx="1">
                  <c:v>0.23333333333333331</c:v>
                </c:pt>
                <c:pt idx="2">
                  <c:v>0.24333333333333332</c:v>
                </c:pt>
                <c:pt idx="3">
                  <c:v>6.9999999999999993E-2</c:v>
                </c:pt>
                <c:pt idx="4">
                  <c:v>1.7733333333333334</c:v>
                </c:pt>
                <c:pt idx="5">
                  <c:v>0.313333333333333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F6B-4ADA-B1B2-83963F0246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701552"/>
        <c:axId val="1734685744"/>
      </c:lineChart>
      <c:catAx>
        <c:axId val="1734699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82000"/>
        <c:crosses val="autoZero"/>
        <c:auto val="1"/>
        <c:lblAlgn val="ctr"/>
        <c:lblOffset val="100"/>
        <c:noMultiLvlLbl val="0"/>
      </c:catAx>
      <c:valAx>
        <c:axId val="173468200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99472"/>
        <c:crosses val="autoZero"/>
        <c:crossBetween val="between"/>
      </c:valAx>
      <c:valAx>
        <c:axId val="1734685744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701552"/>
        <c:crosses val="max"/>
        <c:crossBetween val="between"/>
      </c:valAx>
      <c:catAx>
        <c:axId val="17347015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8574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34770114942528"/>
          <c:y val="3.907013888888889E-2"/>
          <c:w val="0.76513984674329505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349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351:$X$351</c:f>
                <c:numCache>
                  <c:formatCode>General</c:formatCode>
                  <c:ptCount val="6"/>
                  <c:pt idx="0">
                    <c:v>8.713325161423946E-2</c:v>
                  </c:pt>
                  <c:pt idx="1">
                    <c:v>3.4480085220452733E-2</c:v>
                  </c:pt>
                  <c:pt idx="2">
                    <c:v>7.681060977191248E-2</c:v>
                  </c:pt>
                  <c:pt idx="3">
                    <c:v>8.3078895648267589E-3</c:v>
                  </c:pt>
                  <c:pt idx="4">
                    <c:v>2.3528939332386166E-2</c:v>
                  </c:pt>
                  <c:pt idx="5">
                    <c:v>7.5272392284588915E-2</c:v>
                  </c:pt>
                </c:numCache>
              </c:numRef>
            </c:plus>
            <c:minus>
              <c:numRef>
                <c:f>Sheet1!$S$351:$X$351</c:f>
                <c:numCache>
                  <c:formatCode>General</c:formatCode>
                  <c:ptCount val="6"/>
                  <c:pt idx="0">
                    <c:v>8.713325161423946E-2</c:v>
                  </c:pt>
                  <c:pt idx="1">
                    <c:v>3.4480085220452733E-2</c:v>
                  </c:pt>
                  <c:pt idx="2">
                    <c:v>7.681060977191248E-2</c:v>
                  </c:pt>
                  <c:pt idx="3">
                    <c:v>8.3078895648267589E-3</c:v>
                  </c:pt>
                  <c:pt idx="4">
                    <c:v>2.3528939332386166E-2</c:v>
                  </c:pt>
                  <c:pt idx="5">
                    <c:v>7.5272392284588915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348:$X$348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349:$X$349</c:f>
              <c:numCache>
                <c:formatCode>General</c:formatCode>
                <c:ptCount val="6"/>
                <c:pt idx="0">
                  <c:v>1.0024547313384897</c:v>
                </c:pt>
                <c:pt idx="1">
                  <c:v>0.392385421828366</c:v>
                </c:pt>
                <c:pt idx="2">
                  <c:v>0.5311870801113866</c:v>
                </c:pt>
                <c:pt idx="3">
                  <c:v>0.17128495506656286</c:v>
                </c:pt>
                <c:pt idx="4">
                  <c:v>0.24277795447599659</c:v>
                </c:pt>
                <c:pt idx="5">
                  <c:v>0.441862539993527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26D-4127-A903-7F60FD1CC3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702384"/>
        <c:axId val="1734691568"/>
      </c:barChart>
      <c:lineChart>
        <c:grouping val="standard"/>
        <c:varyColors val="0"/>
        <c:ser>
          <c:idx val="1"/>
          <c:order val="1"/>
          <c:tx>
            <c:strRef>
              <c:f>Sheet1!$R$350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348:$X$348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350:$X$350</c:f>
              <c:numCache>
                <c:formatCode>General</c:formatCode>
                <c:ptCount val="6"/>
                <c:pt idx="0">
                  <c:v>17.52</c:v>
                </c:pt>
                <c:pt idx="1">
                  <c:v>7.1033333333333344</c:v>
                </c:pt>
                <c:pt idx="2">
                  <c:v>11.530000000000001</c:v>
                </c:pt>
                <c:pt idx="3">
                  <c:v>0.11</c:v>
                </c:pt>
                <c:pt idx="4">
                  <c:v>1.2699999999999998</c:v>
                </c:pt>
                <c:pt idx="5">
                  <c:v>0.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26D-4127-A903-7F60FD1CC3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704464"/>
        <c:axId val="1734691984"/>
      </c:lineChart>
      <c:catAx>
        <c:axId val="1734702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91568"/>
        <c:crosses val="autoZero"/>
        <c:auto val="1"/>
        <c:lblAlgn val="ctr"/>
        <c:lblOffset val="100"/>
        <c:noMultiLvlLbl val="0"/>
      </c:catAx>
      <c:valAx>
        <c:axId val="173469156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702384"/>
        <c:crosses val="autoZero"/>
        <c:crossBetween val="between"/>
      </c:valAx>
      <c:valAx>
        <c:axId val="1734691984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704464"/>
        <c:crosses val="max"/>
        <c:crossBetween val="between"/>
      </c:valAx>
      <c:catAx>
        <c:axId val="173470446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9198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34770114942528"/>
          <c:y val="3.907013888888889E-2"/>
          <c:w val="0.76513984942392888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395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397:$X$397</c:f>
                <c:numCache>
                  <c:formatCode>General</c:formatCode>
                  <c:ptCount val="6"/>
                  <c:pt idx="0">
                    <c:v>7.8054637245847547E-2</c:v>
                  </c:pt>
                  <c:pt idx="1">
                    <c:v>0.26727020715567928</c:v>
                  </c:pt>
                  <c:pt idx="2">
                    <c:v>0.31446238758687028</c:v>
                  </c:pt>
                  <c:pt idx="3">
                    <c:v>2.8117840272369268E-2</c:v>
                  </c:pt>
                  <c:pt idx="4">
                    <c:v>9.9477346259250254E-2</c:v>
                  </c:pt>
                  <c:pt idx="5">
                    <c:v>2.260991745030172E-2</c:v>
                  </c:pt>
                </c:numCache>
              </c:numRef>
            </c:plus>
            <c:minus>
              <c:numRef>
                <c:f>Sheet1!$S$397:$X$397</c:f>
                <c:numCache>
                  <c:formatCode>General</c:formatCode>
                  <c:ptCount val="6"/>
                  <c:pt idx="0">
                    <c:v>7.8054637245847547E-2</c:v>
                  </c:pt>
                  <c:pt idx="1">
                    <c:v>0.26727020715567928</c:v>
                  </c:pt>
                  <c:pt idx="2">
                    <c:v>0.31446238758687028</c:v>
                  </c:pt>
                  <c:pt idx="3">
                    <c:v>2.8117840272369268E-2</c:v>
                  </c:pt>
                  <c:pt idx="4">
                    <c:v>9.9477346259250254E-2</c:v>
                  </c:pt>
                  <c:pt idx="5">
                    <c:v>2.260991745030172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394:$X$394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395:$X$395</c:f>
              <c:numCache>
                <c:formatCode>General</c:formatCode>
                <c:ptCount val="6"/>
                <c:pt idx="0">
                  <c:v>1.0020001861854089</c:v>
                </c:pt>
                <c:pt idx="1">
                  <c:v>3.0464500630508691</c:v>
                </c:pt>
                <c:pt idx="2">
                  <c:v>2.4425461421267616</c:v>
                </c:pt>
                <c:pt idx="3">
                  <c:v>0.7324051099232497</c:v>
                </c:pt>
                <c:pt idx="4">
                  <c:v>0.75698092184324528</c:v>
                </c:pt>
                <c:pt idx="5">
                  <c:v>0.342795987521910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49-4790-9D82-F7B668E144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599632"/>
        <c:axId val="1734580080"/>
      </c:barChart>
      <c:lineChart>
        <c:grouping val="standard"/>
        <c:varyColors val="0"/>
        <c:ser>
          <c:idx val="1"/>
          <c:order val="1"/>
          <c:tx>
            <c:strRef>
              <c:f>Sheet1!$R$396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394:$X$394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396:$X$396</c:f>
              <c:numCache>
                <c:formatCode>General</c:formatCode>
                <c:ptCount val="6"/>
                <c:pt idx="0">
                  <c:v>54.803333333333335</c:v>
                </c:pt>
                <c:pt idx="1">
                  <c:v>227.78</c:v>
                </c:pt>
                <c:pt idx="2">
                  <c:v>178.09666666666666</c:v>
                </c:pt>
                <c:pt idx="3">
                  <c:v>29.02333333333333</c:v>
                </c:pt>
                <c:pt idx="4">
                  <c:v>31.356666666666666</c:v>
                </c:pt>
                <c:pt idx="5">
                  <c:v>21.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D49-4790-9D82-F7B668E144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590896"/>
        <c:axId val="1734578000"/>
      </c:lineChart>
      <c:catAx>
        <c:axId val="1734599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80080"/>
        <c:crosses val="autoZero"/>
        <c:auto val="1"/>
        <c:lblAlgn val="ctr"/>
        <c:lblOffset val="100"/>
        <c:noMultiLvlLbl val="0"/>
      </c:catAx>
      <c:valAx>
        <c:axId val="173458008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99632"/>
        <c:crosses val="autoZero"/>
        <c:crossBetween val="between"/>
      </c:valAx>
      <c:valAx>
        <c:axId val="1734578000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90896"/>
        <c:crosses val="max"/>
        <c:crossBetween val="between"/>
      </c:valAx>
      <c:catAx>
        <c:axId val="173459089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57800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182950191570876E-2"/>
          <c:y val="3.907013888888889E-2"/>
          <c:w val="0.77122222222222225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418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420:$X$420</c:f>
                <c:numCache>
                  <c:formatCode>General</c:formatCode>
                  <c:ptCount val="6"/>
                  <c:pt idx="0">
                    <c:v>9.6530189768511909E-2</c:v>
                  </c:pt>
                  <c:pt idx="1">
                    <c:v>0.24278783460399489</c:v>
                  </c:pt>
                  <c:pt idx="2">
                    <c:v>0.54957725712558247</c:v>
                  </c:pt>
                  <c:pt idx="3">
                    <c:v>0.11050942829580079</c:v>
                  </c:pt>
                  <c:pt idx="4">
                    <c:v>2.0452037409664445</c:v>
                  </c:pt>
                  <c:pt idx="5">
                    <c:v>5.9267627447580757</c:v>
                  </c:pt>
                </c:numCache>
              </c:numRef>
            </c:plus>
            <c:minus>
              <c:numRef>
                <c:f>Sheet1!$S$420:$X$420</c:f>
                <c:numCache>
                  <c:formatCode>General</c:formatCode>
                  <c:ptCount val="6"/>
                  <c:pt idx="0">
                    <c:v>9.6530189768511909E-2</c:v>
                  </c:pt>
                  <c:pt idx="1">
                    <c:v>0.24278783460399489</c:v>
                  </c:pt>
                  <c:pt idx="2">
                    <c:v>0.54957725712558247</c:v>
                  </c:pt>
                  <c:pt idx="3">
                    <c:v>0.11050942829580079</c:v>
                  </c:pt>
                  <c:pt idx="4">
                    <c:v>2.0452037409664445</c:v>
                  </c:pt>
                  <c:pt idx="5">
                    <c:v>5.926762744758075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417:$X$417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418:$X$418</c:f>
              <c:numCache>
                <c:formatCode>General</c:formatCode>
                <c:ptCount val="6"/>
                <c:pt idx="0">
                  <c:v>0.99851472129052332</c:v>
                </c:pt>
                <c:pt idx="1">
                  <c:v>1.8937438383764953</c:v>
                </c:pt>
                <c:pt idx="2">
                  <c:v>3.1565785913776598</c:v>
                </c:pt>
                <c:pt idx="3">
                  <c:v>1.0682337279267478</c:v>
                </c:pt>
                <c:pt idx="4">
                  <c:v>17.068947140738171</c:v>
                </c:pt>
                <c:pt idx="5">
                  <c:v>24.6086308224745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1D-4856-948E-02529E6F69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578832"/>
        <c:axId val="1734588400"/>
      </c:barChart>
      <c:lineChart>
        <c:grouping val="standard"/>
        <c:varyColors val="0"/>
        <c:ser>
          <c:idx val="1"/>
          <c:order val="1"/>
          <c:tx>
            <c:strRef>
              <c:f>Sheet1!$R$419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417:$X$417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419:$X$419</c:f>
              <c:numCache>
                <c:formatCode>General</c:formatCode>
                <c:ptCount val="6"/>
                <c:pt idx="0">
                  <c:v>3.3333333333333333E-2</c:v>
                </c:pt>
                <c:pt idx="1">
                  <c:v>0.5</c:v>
                </c:pt>
                <c:pt idx="2">
                  <c:v>1.3333333333333333</c:v>
                </c:pt>
                <c:pt idx="3">
                  <c:v>0</c:v>
                </c:pt>
                <c:pt idx="4">
                  <c:v>1.04</c:v>
                </c:pt>
                <c:pt idx="5">
                  <c:v>5.946666666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71D-4856-948E-02529E6F69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597968"/>
        <c:axId val="1734587152"/>
      </c:lineChart>
      <c:catAx>
        <c:axId val="1734578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88400"/>
        <c:crosses val="autoZero"/>
        <c:auto val="1"/>
        <c:lblAlgn val="ctr"/>
        <c:lblOffset val="100"/>
        <c:noMultiLvlLbl val="0"/>
      </c:catAx>
      <c:valAx>
        <c:axId val="173458840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78832"/>
        <c:crosses val="autoZero"/>
        <c:crossBetween val="between"/>
      </c:valAx>
      <c:valAx>
        <c:axId val="1734587152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97968"/>
        <c:crosses val="max"/>
        <c:crossBetween val="between"/>
      </c:valAx>
      <c:catAx>
        <c:axId val="17345979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58715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34770114942528"/>
          <c:y val="3.907013888888889E-2"/>
          <c:w val="0.76513984674329505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44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443:$X$44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4.7375157571529276E-2</c:v>
                  </c:pt>
                  <c:pt idx="4">
                    <c:v>2.8192041288849692E-3</c:v>
                  </c:pt>
                  <c:pt idx="5">
                    <c:v>2.1609030597906404E-3</c:v>
                  </c:pt>
                </c:numCache>
              </c:numRef>
            </c:plus>
            <c:minus>
              <c:numRef>
                <c:f>Sheet1!$S$443:$X$44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4.7375157571529276E-2</c:v>
                  </c:pt>
                  <c:pt idx="4">
                    <c:v>2.8192041288849692E-3</c:v>
                  </c:pt>
                  <c:pt idx="5">
                    <c:v>2.1609030597906404E-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440:$X$440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441:$X$441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0007617666792428</c:v>
                </c:pt>
                <c:pt idx="4">
                  <c:v>3.4093132662898948E-3</c:v>
                </c:pt>
                <c:pt idx="5">
                  <c:v>5.139482749221964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D8-44EC-BD84-89F37CFCF6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687408"/>
        <c:axId val="1734696976"/>
      </c:barChart>
      <c:lineChart>
        <c:grouping val="standard"/>
        <c:varyColors val="0"/>
        <c:ser>
          <c:idx val="1"/>
          <c:order val="1"/>
          <c:tx>
            <c:strRef>
              <c:f>Sheet1!$R$442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440:$X$440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442:$X$442</c:f>
              <c:numCache>
                <c:formatCode>General</c:formatCode>
                <c:ptCount val="6"/>
                <c:pt idx="0">
                  <c:v>0.11333333333333333</c:v>
                </c:pt>
                <c:pt idx="1">
                  <c:v>0</c:v>
                </c:pt>
                <c:pt idx="2">
                  <c:v>0</c:v>
                </c:pt>
                <c:pt idx="3">
                  <c:v>53.376666666666665</c:v>
                </c:pt>
                <c:pt idx="4">
                  <c:v>0.02</c:v>
                </c:pt>
                <c:pt idx="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3D8-44EC-BD84-89F37CFCF6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682832"/>
        <c:axId val="1734700304"/>
      </c:lineChart>
      <c:catAx>
        <c:axId val="173468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96976"/>
        <c:crosses val="autoZero"/>
        <c:auto val="1"/>
        <c:lblAlgn val="ctr"/>
        <c:lblOffset val="100"/>
        <c:noMultiLvlLbl val="0"/>
      </c:catAx>
      <c:valAx>
        <c:axId val="173469697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87408"/>
        <c:crosses val="autoZero"/>
        <c:crossBetween val="between"/>
      </c:valAx>
      <c:valAx>
        <c:axId val="1734700304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82832"/>
        <c:crosses val="max"/>
        <c:crossBetween val="between"/>
      </c:valAx>
      <c:catAx>
        <c:axId val="17346828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70030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59292929292929"/>
          <c:y val="3.907013888888889E-2"/>
          <c:w val="0.81647070707070712"/>
          <c:h val="0.846790972222222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5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7:$X$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4237685248988205</c:v>
                  </c:pt>
                  <c:pt idx="2">
                    <c:v>0</c:v>
                  </c:pt>
                  <c:pt idx="3">
                    <c:v>1.9391986405098971</c:v>
                  </c:pt>
                  <c:pt idx="4">
                    <c:v>0.64390412610777459</c:v>
                  </c:pt>
                  <c:pt idx="5">
                    <c:v>1.2705034576597283</c:v>
                  </c:pt>
                </c:numCache>
              </c:numRef>
            </c:plus>
            <c:minus>
              <c:numRef>
                <c:f>Sheet1!$S$7:$X$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4237685248988205</c:v>
                  </c:pt>
                  <c:pt idx="2">
                    <c:v>0</c:v>
                  </c:pt>
                  <c:pt idx="3">
                    <c:v>1.9391986405098971</c:v>
                  </c:pt>
                  <c:pt idx="4">
                    <c:v>0.64390412610777459</c:v>
                  </c:pt>
                  <c:pt idx="5">
                    <c:v>1.270503457659728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4:$X$4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5:$X$5</c:f>
              <c:numCache>
                <c:formatCode>General</c:formatCode>
                <c:ptCount val="6"/>
                <c:pt idx="0">
                  <c:v>0</c:v>
                </c:pt>
                <c:pt idx="1">
                  <c:v>1.0050550154406774</c:v>
                </c:pt>
                <c:pt idx="2">
                  <c:v>0</c:v>
                </c:pt>
                <c:pt idx="3">
                  <c:v>19.814202057554112</c:v>
                </c:pt>
                <c:pt idx="4">
                  <c:v>8.7661818003861072</c:v>
                </c:pt>
                <c:pt idx="5">
                  <c:v>6.46482538922878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B6-425F-ABF4-97A0E922CA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703632"/>
        <c:axId val="1734698224"/>
      </c:barChart>
      <c:lineChart>
        <c:grouping val="standard"/>
        <c:varyColors val="0"/>
        <c:ser>
          <c:idx val="1"/>
          <c:order val="1"/>
          <c:tx>
            <c:strRef>
              <c:f>Sheet1!$R$6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4:$X$4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6:$X$6</c:f>
              <c:numCache>
                <c:formatCode>General</c:formatCode>
                <c:ptCount val="6"/>
                <c:pt idx="0">
                  <c:v>2.6666666666666668E-2</c:v>
                </c:pt>
                <c:pt idx="1">
                  <c:v>0.11</c:v>
                </c:pt>
                <c:pt idx="2">
                  <c:v>5.6666666666666664E-2</c:v>
                </c:pt>
                <c:pt idx="3">
                  <c:v>5.95</c:v>
                </c:pt>
                <c:pt idx="4">
                  <c:v>2.5566666666666666</c:v>
                </c:pt>
                <c:pt idx="5">
                  <c:v>1.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0B6-425F-ABF4-97A0E922CA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686992"/>
        <c:axId val="1734695312"/>
      </c:lineChart>
      <c:catAx>
        <c:axId val="1734703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98224"/>
        <c:crosses val="autoZero"/>
        <c:auto val="1"/>
        <c:lblAlgn val="ctr"/>
        <c:lblOffset val="100"/>
        <c:noMultiLvlLbl val="0"/>
      </c:catAx>
      <c:valAx>
        <c:axId val="173469822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703632"/>
        <c:crosses val="autoZero"/>
        <c:crossBetween val="between"/>
      </c:valAx>
      <c:valAx>
        <c:axId val="1734695312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86992"/>
        <c:crosses val="max"/>
        <c:crossBetween val="between"/>
      </c:valAx>
      <c:catAx>
        <c:axId val="17346869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9531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1545454545454545"/>
          <c:y val="0.12729012345679011"/>
          <c:w val="0.35912878787878788"/>
          <c:h val="0.165296296296296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50879629629629"/>
          <c:y val="3.907013888888889E-2"/>
          <c:w val="0.80120000000000002"/>
          <c:h val="0.837576388888888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49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51:$X$51</c:f>
                <c:numCache>
                  <c:formatCode>General</c:formatCode>
                  <c:ptCount val="6"/>
                  <c:pt idx="0">
                    <c:v>6.8785012695250627E-2</c:v>
                  </c:pt>
                  <c:pt idx="1">
                    <c:v>0.16578729242582041</c:v>
                  </c:pt>
                  <c:pt idx="2">
                    <c:v>0.10974064035191106</c:v>
                  </c:pt>
                  <c:pt idx="3">
                    <c:v>0.95577081353958826</c:v>
                  </c:pt>
                  <c:pt idx="4">
                    <c:v>0.37404439978036269</c:v>
                  </c:pt>
                  <c:pt idx="5">
                    <c:v>0.26914457128322061</c:v>
                  </c:pt>
                </c:numCache>
              </c:numRef>
            </c:plus>
            <c:minus>
              <c:numRef>
                <c:f>Sheet1!$S$51:$X$51</c:f>
                <c:numCache>
                  <c:formatCode>General</c:formatCode>
                  <c:ptCount val="6"/>
                  <c:pt idx="0">
                    <c:v>6.8785012695250627E-2</c:v>
                  </c:pt>
                  <c:pt idx="1">
                    <c:v>0.16578729242582041</c:v>
                  </c:pt>
                  <c:pt idx="2">
                    <c:v>0.10974064035191106</c:v>
                  </c:pt>
                  <c:pt idx="3">
                    <c:v>0.95577081353958826</c:v>
                  </c:pt>
                  <c:pt idx="4">
                    <c:v>0.37404439978036269</c:v>
                  </c:pt>
                  <c:pt idx="5">
                    <c:v>0.2691445712832206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S$48:$X$48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49:$X$49</c:f>
              <c:numCache>
                <c:formatCode>General</c:formatCode>
                <c:ptCount val="6"/>
                <c:pt idx="0">
                  <c:v>0.78068119689362847</c:v>
                </c:pt>
                <c:pt idx="1">
                  <c:v>0.46111477324379024</c:v>
                </c:pt>
                <c:pt idx="2">
                  <c:v>0.57759835096459089</c:v>
                </c:pt>
                <c:pt idx="3">
                  <c:v>54.700413233446319</c:v>
                </c:pt>
                <c:pt idx="4">
                  <c:v>6.5655758573603533</c:v>
                </c:pt>
                <c:pt idx="5">
                  <c:v>1.03469733622321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BC-4368-8B9D-4311F0518F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695728"/>
        <c:axId val="1734703216"/>
      </c:barChart>
      <c:lineChart>
        <c:grouping val="standard"/>
        <c:varyColors val="0"/>
        <c:ser>
          <c:idx val="1"/>
          <c:order val="1"/>
          <c:tx>
            <c:strRef>
              <c:f>Sheet1!$R$50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48:$X$48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50:$X$50</c:f>
              <c:numCache>
                <c:formatCode>General</c:formatCode>
                <c:ptCount val="6"/>
                <c:pt idx="0">
                  <c:v>0.11</c:v>
                </c:pt>
                <c:pt idx="1">
                  <c:v>5.3333333333333337E-2</c:v>
                </c:pt>
                <c:pt idx="2">
                  <c:v>0.23333333333333331</c:v>
                </c:pt>
                <c:pt idx="3">
                  <c:v>4.96</c:v>
                </c:pt>
                <c:pt idx="4">
                  <c:v>4.3133333333333335</c:v>
                </c:pt>
                <c:pt idx="5">
                  <c:v>0.156666666666666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FBC-4368-8B9D-4311F0518F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689488"/>
        <c:axId val="1734689072"/>
      </c:lineChart>
      <c:catAx>
        <c:axId val="1734695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703216"/>
        <c:crosses val="autoZero"/>
        <c:auto val="1"/>
        <c:lblAlgn val="ctr"/>
        <c:lblOffset val="100"/>
        <c:noMultiLvlLbl val="0"/>
      </c:catAx>
      <c:valAx>
        <c:axId val="17347032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95728"/>
        <c:crosses val="autoZero"/>
        <c:crossBetween val="between"/>
      </c:valAx>
      <c:valAx>
        <c:axId val="1734689072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89488"/>
        <c:crosses val="max"/>
        <c:crossBetween val="between"/>
      </c:valAx>
      <c:catAx>
        <c:axId val="173468948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8907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42121212121212"/>
          <c:y val="3.907013888888889E-2"/>
          <c:w val="0.75689961013645224"/>
          <c:h val="0.846790972222222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7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73:$X$73</c:f>
                <c:numCache>
                  <c:formatCode>General</c:formatCode>
                  <c:ptCount val="6"/>
                  <c:pt idx="0">
                    <c:v>0.10159520961316278</c:v>
                  </c:pt>
                  <c:pt idx="1">
                    <c:v>2.6664372454486382E-3</c:v>
                  </c:pt>
                  <c:pt idx="2">
                    <c:v>3.3193312420880827E-3</c:v>
                  </c:pt>
                  <c:pt idx="3">
                    <c:v>5.4138358419213726E-3</c:v>
                  </c:pt>
                  <c:pt idx="4">
                    <c:v>2.6603418437562772E-3</c:v>
                  </c:pt>
                  <c:pt idx="5">
                    <c:v>1.3490940053243739E-3</c:v>
                  </c:pt>
                </c:numCache>
              </c:numRef>
            </c:plus>
            <c:minus>
              <c:numRef>
                <c:f>Sheet1!$S$73:$X$73</c:f>
                <c:numCache>
                  <c:formatCode>General</c:formatCode>
                  <c:ptCount val="6"/>
                  <c:pt idx="0">
                    <c:v>0.10159520961316278</c:v>
                  </c:pt>
                  <c:pt idx="1">
                    <c:v>2.6664372454486382E-3</c:v>
                  </c:pt>
                  <c:pt idx="2">
                    <c:v>3.3193312420880827E-3</c:v>
                  </c:pt>
                  <c:pt idx="3">
                    <c:v>5.4138358419213726E-3</c:v>
                  </c:pt>
                  <c:pt idx="4">
                    <c:v>2.6603418437562772E-3</c:v>
                  </c:pt>
                  <c:pt idx="5">
                    <c:v>1.3490940053243739E-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70:$X$70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71:$X$71</c:f>
              <c:numCache>
                <c:formatCode>General</c:formatCode>
                <c:ptCount val="6"/>
                <c:pt idx="0">
                  <c:v>1.0266379526770184</c:v>
                </c:pt>
                <c:pt idx="1">
                  <c:v>3.3409281988041696E-2</c:v>
                </c:pt>
                <c:pt idx="2">
                  <c:v>1.7640642393202205E-2</c:v>
                </c:pt>
                <c:pt idx="3">
                  <c:v>0.11888857115041833</c:v>
                </c:pt>
                <c:pt idx="4">
                  <c:v>2.3405539421417598E-2</c:v>
                </c:pt>
                <c:pt idx="5">
                  <c:v>9.929556535547959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5DE-442A-8466-EBAEC50983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686576"/>
        <c:axId val="1734699888"/>
      </c:barChart>
      <c:lineChart>
        <c:grouping val="standard"/>
        <c:varyColors val="0"/>
        <c:ser>
          <c:idx val="1"/>
          <c:order val="1"/>
          <c:tx>
            <c:strRef>
              <c:f>Sheet1!$R$72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70:$X$70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72:$X$72</c:f>
              <c:numCache>
                <c:formatCode>General</c:formatCode>
                <c:ptCount val="6"/>
                <c:pt idx="0">
                  <c:v>370.97333333333336</c:v>
                </c:pt>
                <c:pt idx="1">
                  <c:v>19.483333333333334</c:v>
                </c:pt>
                <c:pt idx="2">
                  <c:v>8.74</c:v>
                </c:pt>
                <c:pt idx="3">
                  <c:v>45.636666666666663</c:v>
                </c:pt>
                <c:pt idx="4">
                  <c:v>20.533333333333331</c:v>
                </c:pt>
                <c:pt idx="5">
                  <c:v>6.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5DE-442A-8466-EBAEC50983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701968"/>
        <c:axId val="1734688656"/>
      </c:lineChart>
      <c:catAx>
        <c:axId val="1734686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99888"/>
        <c:crosses val="autoZero"/>
        <c:auto val="1"/>
        <c:lblAlgn val="ctr"/>
        <c:lblOffset val="100"/>
        <c:noMultiLvlLbl val="0"/>
      </c:catAx>
      <c:valAx>
        <c:axId val="173469988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86576"/>
        <c:crosses val="autoZero"/>
        <c:crossBetween val="between"/>
      </c:valAx>
      <c:valAx>
        <c:axId val="1734688656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701968"/>
        <c:crosses val="max"/>
        <c:crossBetween val="between"/>
        <c:majorUnit val="100"/>
      </c:valAx>
      <c:catAx>
        <c:axId val="17347019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8865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182950191570876E-2"/>
          <c:y val="3.907013888888889E-2"/>
          <c:w val="0.77730459770114946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94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T$96:$Y$96</c:f>
                <c:numCache>
                  <c:formatCode>General</c:formatCode>
                  <c:ptCount val="6"/>
                  <c:pt idx="0">
                    <c:v>0.13391571866263541</c:v>
                  </c:pt>
                  <c:pt idx="1">
                    <c:v>0.59096990287270434</c:v>
                  </c:pt>
                  <c:pt idx="2">
                    <c:v>1.2809158042463824</c:v>
                  </c:pt>
                  <c:pt idx="3">
                    <c:v>9.1906994144184795E-2</c:v>
                  </c:pt>
                  <c:pt idx="4">
                    <c:v>0.5916058715684982</c:v>
                  </c:pt>
                  <c:pt idx="5">
                    <c:v>0.51739935238244972</c:v>
                  </c:pt>
                </c:numCache>
              </c:numRef>
            </c:plus>
            <c:minus>
              <c:numRef>
                <c:f>Sheet1!$T$96:$Y$96</c:f>
                <c:numCache>
                  <c:formatCode>General</c:formatCode>
                  <c:ptCount val="6"/>
                  <c:pt idx="0">
                    <c:v>0.13391571866263541</c:v>
                  </c:pt>
                  <c:pt idx="1">
                    <c:v>0.59096990287270434</c:v>
                  </c:pt>
                  <c:pt idx="2">
                    <c:v>1.2809158042463824</c:v>
                  </c:pt>
                  <c:pt idx="3">
                    <c:v>9.1906994144184795E-2</c:v>
                  </c:pt>
                  <c:pt idx="4">
                    <c:v>0.5916058715684982</c:v>
                  </c:pt>
                  <c:pt idx="5">
                    <c:v>0.5173993523824497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93:$Y$93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T$94:$Y$94</c:f>
              <c:numCache>
                <c:formatCode>General</c:formatCode>
                <c:ptCount val="6"/>
                <c:pt idx="0">
                  <c:v>1.0102814658576136</c:v>
                </c:pt>
                <c:pt idx="1">
                  <c:v>11.091592797479549</c:v>
                </c:pt>
                <c:pt idx="2">
                  <c:v>14.727348487708312</c:v>
                </c:pt>
                <c:pt idx="3">
                  <c:v>6.3500457839526803</c:v>
                </c:pt>
                <c:pt idx="4">
                  <c:v>8.7069811030257132</c:v>
                </c:pt>
                <c:pt idx="5">
                  <c:v>4.7217747987951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26-4BDB-B987-DA39164447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595472"/>
        <c:axId val="1734576752"/>
      </c:barChart>
      <c:lineChart>
        <c:grouping val="standard"/>
        <c:varyColors val="0"/>
        <c:ser>
          <c:idx val="1"/>
          <c:order val="1"/>
          <c:tx>
            <c:strRef>
              <c:f>Sheet1!$S$95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T$93:$Y$93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T$95:$Y$95</c:f>
              <c:numCache>
                <c:formatCode>General</c:formatCode>
                <c:ptCount val="6"/>
                <c:pt idx="0">
                  <c:v>9.5133333333333336</c:v>
                </c:pt>
                <c:pt idx="1">
                  <c:v>113.86666666666667</c:v>
                </c:pt>
                <c:pt idx="2">
                  <c:v>128.04500000000002</c:v>
                </c:pt>
                <c:pt idx="3">
                  <c:v>77.73</c:v>
                </c:pt>
                <c:pt idx="4">
                  <c:v>85.2</c:v>
                </c:pt>
                <c:pt idx="5">
                  <c:v>58.140000000000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126-4BDB-B987-DA39164447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585488"/>
        <c:axId val="1734590480"/>
      </c:lineChart>
      <c:catAx>
        <c:axId val="1734595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76752"/>
        <c:crosses val="autoZero"/>
        <c:auto val="1"/>
        <c:lblAlgn val="ctr"/>
        <c:lblOffset val="100"/>
        <c:noMultiLvlLbl val="0"/>
      </c:catAx>
      <c:valAx>
        <c:axId val="173457675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95472"/>
        <c:crosses val="autoZero"/>
        <c:crossBetween val="between"/>
      </c:valAx>
      <c:valAx>
        <c:axId val="1734590480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85488"/>
        <c:crosses val="max"/>
        <c:crossBetween val="between"/>
      </c:valAx>
      <c:catAx>
        <c:axId val="173458548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59048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853448275862072E-2"/>
          <c:y val="3.907013888888889E-2"/>
          <c:w val="0.75905747126436784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118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T$120:$Y$120</c:f>
                <c:numCache>
                  <c:formatCode>General</c:formatCode>
                  <c:ptCount val="6"/>
                  <c:pt idx="0">
                    <c:v>0.15106439701737528</c:v>
                  </c:pt>
                  <c:pt idx="1">
                    <c:v>7.2262877105407797E-2</c:v>
                  </c:pt>
                  <c:pt idx="2">
                    <c:v>0.17235480518190971</c:v>
                  </c:pt>
                  <c:pt idx="3">
                    <c:v>1.421105840659128E-2</c:v>
                  </c:pt>
                  <c:pt idx="4">
                    <c:v>0.35292506661670459</c:v>
                  </c:pt>
                  <c:pt idx="5">
                    <c:v>0.14033233166993747</c:v>
                  </c:pt>
                </c:numCache>
              </c:numRef>
            </c:plus>
            <c:minus>
              <c:numRef>
                <c:f>Sheet1!$T$120:$Y$120</c:f>
                <c:numCache>
                  <c:formatCode>General</c:formatCode>
                  <c:ptCount val="6"/>
                  <c:pt idx="0">
                    <c:v>0.15106439701737528</c:v>
                  </c:pt>
                  <c:pt idx="1">
                    <c:v>7.2262877105407797E-2</c:v>
                  </c:pt>
                  <c:pt idx="2">
                    <c:v>0.17235480518190971</c:v>
                  </c:pt>
                  <c:pt idx="3">
                    <c:v>1.421105840659128E-2</c:v>
                  </c:pt>
                  <c:pt idx="4">
                    <c:v>0.35292506661670459</c:v>
                  </c:pt>
                  <c:pt idx="5">
                    <c:v>0.1403323316699374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117:$Y$117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T$118:$Y$118</c:f>
              <c:numCache>
                <c:formatCode>General</c:formatCode>
                <c:ptCount val="6"/>
                <c:pt idx="0">
                  <c:v>1.0071816027611662</c:v>
                </c:pt>
                <c:pt idx="1">
                  <c:v>0.71616258043098091</c:v>
                </c:pt>
                <c:pt idx="2">
                  <c:v>1.2115432758922322</c:v>
                </c:pt>
                <c:pt idx="3">
                  <c:v>0.81609716065394888</c:v>
                </c:pt>
                <c:pt idx="4">
                  <c:v>2.9893668001257061</c:v>
                </c:pt>
                <c:pt idx="5">
                  <c:v>1.35521615349255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C8-4B0D-A9C1-54FED7547F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596720"/>
        <c:axId val="1734592976"/>
      </c:barChart>
      <c:lineChart>
        <c:grouping val="standard"/>
        <c:varyColors val="0"/>
        <c:ser>
          <c:idx val="1"/>
          <c:order val="1"/>
          <c:tx>
            <c:strRef>
              <c:f>Sheet1!$S$119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T$117:$Y$117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T$119:$Y$119</c:f>
              <c:numCache>
                <c:formatCode>General</c:formatCode>
                <c:ptCount val="6"/>
                <c:pt idx="0">
                  <c:v>1.0599999999999998</c:v>
                </c:pt>
                <c:pt idx="1">
                  <c:v>0.29333333333333333</c:v>
                </c:pt>
                <c:pt idx="2">
                  <c:v>0.56666666666666676</c:v>
                </c:pt>
                <c:pt idx="3">
                  <c:v>11.666666666666666</c:v>
                </c:pt>
                <c:pt idx="4">
                  <c:v>411.4666666666667</c:v>
                </c:pt>
                <c:pt idx="5">
                  <c:v>86.1933333333333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BC8-4B0D-A9C1-54FED7547F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600048"/>
        <c:axId val="1734581744"/>
      </c:lineChart>
      <c:catAx>
        <c:axId val="1734596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92976"/>
        <c:crosses val="autoZero"/>
        <c:auto val="1"/>
        <c:lblAlgn val="ctr"/>
        <c:lblOffset val="100"/>
        <c:noMultiLvlLbl val="0"/>
      </c:catAx>
      <c:valAx>
        <c:axId val="173459297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96720"/>
        <c:crosses val="autoZero"/>
        <c:crossBetween val="between"/>
      </c:valAx>
      <c:valAx>
        <c:axId val="1734581744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00048"/>
        <c:crosses val="max"/>
        <c:crossBetween val="between"/>
      </c:valAx>
      <c:catAx>
        <c:axId val="17346000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58174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351245210727969"/>
          <c:y val="3.907013888888889E-2"/>
          <c:w val="0.75905747126436784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14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T$143:$Y$143</c:f>
                <c:numCache>
                  <c:formatCode>General</c:formatCode>
                  <c:ptCount val="6"/>
                  <c:pt idx="0">
                    <c:v>0.78791178293719943</c:v>
                  </c:pt>
                  <c:pt idx="1">
                    <c:v>8.7475065762872113</c:v>
                  </c:pt>
                  <c:pt idx="2">
                    <c:v>4.8188214054508558</c:v>
                  </c:pt>
                  <c:pt idx="3">
                    <c:v>11.915800468535732</c:v>
                  </c:pt>
                  <c:pt idx="4">
                    <c:v>72.811192187031807</c:v>
                  </c:pt>
                  <c:pt idx="5">
                    <c:v>13.702454011582875</c:v>
                  </c:pt>
                </c:numCache>
              </c:numRef>
            </c:plus>
            <c:minus>
              <c:numRef>
                <c:f>Sheet1!$T$143:$Y$143</c:f>
                <c:numCache>
                  <c:formatCode>General</c:formatCode>
                  <c:ptCount val="6"/>
                  <c:pt idx="0">
                    <c:v>0.78791178293719943</c:v>
                  </c:pt>
                  <c:pt idx="1">
                    <c:v>8.7475065762872113</c:v>
                  </c:pt>
                  <c:pt idx="2">
                    <c:v>4.8188214054508558</c:v>
                  </c:pt>
                  <c:pt idx="3">
                    <c:v>11.915800468535732</c:v>
                  </c:pt>
                  <c:pt idx="4">
                    <c:v>72.811192187031807</c:v>
                  </c:pt>
                  <c:pt idx="5">
                    <c:v>13.70245401158287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140:$Y$140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T$141:$Y$141</c:f>
              <c:numCache>
                <c:formatCode>General</c:formatCode>
                <c:ptCount val="6"/>
                <c:pt idx="0">
                  <c:v>1.152953859754857</c:v>
                </c:pt>
                <c:pt idx="1">
                  <c:v>63.938297515201249</c:v>
                </c:pt>
                <c:pt idx="2">
                  <c:v>8.3844834468180718</c:v>
                </c:pt>
                <c:pt idx="3">
                  <c:v>131.36433213179632</c:v>
                </c:pt>
                <c:pt idx="4">
                  <c:v>662.74913751918155</c:v>
                </c:pt>
                <c:pt idx="5">
                  <c:v>122.745420943792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4B-41DF-980F-A1E9ACC9DF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581328"/>
        <c:axId val="1734583408"/>
      </c:barChart>
      <c:lineChart>
        <c:grouping val="standard"/>
        <c:varyColors val="0"/>
        <c:ser>
          <c:idx val="1"/>
          <c:order val="1"/>
          <c:tx>
            <c:strRef>
              <c:f>Sheet1!$S$142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T$140:$Y$140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T$142:$Y$142</c:f>
              <c:numCache>
                <c:formatCode>General</c:formatCode>
                <c:ptCount val="6"/>
                <c:pt idx="0">
                  <c:v>0</c:v>
                </c:pt>
                <c:pt idx="1">
                  <c:v>2.31</c:v>
                </c:pt>
                <c:pt idx="2">
                  <c:v>0.53666666666666663</c:v>
                </c:pt>
                <c:pt idx="3">
                  <c:v>1.3166666666666667</c:v>
                </c:pt>
                <c:pt idx="4">
                  <c:v>16.573333333333334</c:v>
                </c:pt>
                <c:pt idx="5">
                  <c:v>2.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E4B-41DF-980F-A1E9ACC9DF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593392"/>
        <c:axId val="1734600464"/>
      </c:lineChart>
      <c:catAx>
        <c:axId val="17345813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83408"/>
        <c:crosses val="autoZero"/>
        <c:auto val="1"/>
        <c:lblAlgn val="ctr"/>
        <c:lblOffset val="100"/>
        <c:noMultiLvlLbl val="0"/>
      </c:catAx>
      <c:valAx>
        <c:axId val="173458340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81328"/>
        <c:crosses val="autoZero"/>
        <c:crossBetween val="between"/>
      </c:valAx>
      <c:valAx>
        <c:axId val="1734600464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593392"/>
        <c:crosses val="max"/>
        <c:crossBetween val="between"/>
      </c:valAx>
      <c:catAx>
        <c:axId val="17345933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0046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182950191570876E-2"/>
          <c:y val="3.907013888888889E-2"/>
          <c:w val="0.77730459770114946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188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T$190:$Y$190</c:f>
                <c:numCache>
                  <c:formatCode>General</c:formatCode>
                  <c:ptCount val="6"/>
                  <c:pt idx="0">
                    <c:v>0.10487003816341907</c:v>
                  </c:pt>
                  <c:pt idx="1">
                    <c:v>0.64060271023663184</c:v>
                  </c:pt>
                  <c:pt idx="2">
                    <c:v>0.58689251960964617</c:v>
                  </c:pt>
                  <c:pt idx="3">
                    <c:v>3.7380452216420097</c:v>
                  </c:pt>
                  <c:pt idx="4">
                    <c:v>4.8714075093234213</c:v>
                  </c:pt>
                  <c:pt idx="5">
                    <c:v>6.6449512228919616</c:v>
                  </c:pt>
                </c:numCache>
              </c:numRef>
            </c:plus>
            <c:minus>
              <c:numRef>
                <c:f>Sheet1!$T$190:$Y$190</c:f>
                <c:numCache>
                  <c:formatCode>General</c:formatCode>
                  <c:ptCount val="6"/>
                  <c:pt idx="0">
                    <c:v>0.10487003816341907</c:v>
                  </c:pt>
                  <c:pt idx="1">
                    <c:v>0.64060271023663184</c:v>
                  </c:pt>
                  <c:pt idx="2">
                    <c:v>0.58689251960964617</c:v>
                  </c:pt>
                  <c:pt idx="3">
                    <c:v>3.7380452216420097</c:v>
                  </c:pt>
                  <c:pt idx="4">
                    <c:v>4.8714075093234213</c:v>
                  </c:pt>
                  <c:pt idx="5">
                    <c:v>6.644951222891961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187:$Y$187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T$188:$Y$188</c:f>
              <c:numCache>
                <c:formatCode>General</c:formatCode>
                <c:ptCount val="6"/>
                <c:pt idx="0">
                  <c:v>1.0037500696944586</c:v>
                </c:pt>
                <c:pt idx="1">
                  <c:v>2.0692167199123199</c:v>
                </c:pt>
                <c:pt idx="2">
                  <c:v>2.1916880333723907</c:v>
                </c:pt>
                <c:pt idx="3">
                  <c:v>54.781813243525221</c:v>
                </c:pt>
                <c:pt idx="4">
                  <c:v>60.677169006637094</c:v>
                </c:pt>
                <c:pt idx="5">
                  <c:v>49.2686805660258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41-4000-9463-CC04FAC5B6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642480"/>
        <c:axId val="1734644976"/>
      </c:barChart>
      <c:lineChart>
        <c:grouping val="standard"/>
        <c:varyColors val="0"/>
        <c:ser>
          <c:idx val="1"/>
          <c:order val="1"/>
          <c:tx>
            <c:strRef>
              <c:f>Sheet1!$S$189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T$187:$Y$187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T$189:$Y$189</c:f>
              <c:numCache>
                <c:formatCode>General</c:formatCode>
                <c:ptCount val="6"/>
                <c:pt idx="0">
                  <c:v>13.475</c:v>
                </c:pt>
                <c:pt idx="1">
                  <c:v>9.3666666666666654</c:v>
                </c:pt>
                <c:pt idx="2">
                  <c:v>5.91</c:v>
                </c:pt>
                <c:pt idx="3">
                  <c:v>195.89000000000001</c:v>
                </c:pt>
                <c:pt idx="4">
                  <c:v>347.95666666666665</c:v>
                </c:pt>
                <c:pt idx="5">
                  <c:v>226.87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041-4000-9463-CC04FAC5B6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651632"/>
        <c:axId val="1734646224"/>
      </c:lineChart>
      <c:catAx>
        <c:axId val="17346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44976"/>
        <c:crosses val="autoZero"/>
        <c:auto val="1"/>
        <c:lblAlgn val="ctr"/>
        <c:lblOffset val="100"/>
        <c:noMultiLvlLbl val="0"/>
      </c:catAx>
      <c:valAx>
        <c:axId val="173464497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42480"/>
        <c:crosses val="autoZero"/>
        <c:crossBetween val="between"/>
      </c:valAx>
      <c:valAx>
        <c:axId val="1734646224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51632"/>
        <c:crosses val="max"/>
        <c:crossBetween val="between"/>
      </c:valAx>
      <c:catAx>
        <c:axId val="17346516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4622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34770114942528"/>
          <c:y val="3.907013888888889E-2"/>
          <c:w val="0.76513984674329505"/>
          <c:h val="0.82763958333333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21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213:$X$213</c:f>
                <c:numCache>
                  <c:formatCode>General</c:formatCode>
                  <c:ptCount val="6"/>
                  <c:pt idx="0">
                    <c:v>0.10149993861234476</c:v>
                  </c:pt>
                  <c:pt idx="1">
                    <c:v>2.4729472821355358E-2</c:v>
                  </c:pt>
                  <c:pt idx="2">
                    <c:v>8.4703428022700117E-2</c:v>
                  </c:pt>
                  <c:pt idx="3">
                    <c:v>5.7338925986412555E-3</c:v>
                  </c:pt>
                  <c:pt idx="4">
                    <c:v>2.7346814120401118E-3</c:v>
                  </c:pt>
                  <c:pt idx="5">
                    <c:v>2.4196580454357835E-3</c:v>
                  </c:pt>
                </c:numCache>
              </c:numRef>
            </c:plus>
            <c:minus>
              <c:numRef>
                <c:f>Sheet1!$S$213:$X$213</c:f>
                <c:numCache>
                  <c:formatCode>General</c:formatCode>
                  <c:ptCount val="6"/>
                  <c:pt idx="0">
                    <c:v>0.10149993861234476</c:v>
                  </c:pt>
                  <c:pt idx="1">
                    <c:v>2.4729472821355358E-2</c:v>
                  </c:pt>
                  <c:pt idx="2">
                    <c:v>8.4703428022700117E-2</c:v>
                  </c:pt>
                  <c:pt idx="3">
                    <c:v>5.7338925986412555E-3</c:v>
                  </c:pt>
                  <c:pt idx="4">
                    <c:v>2.7346814120401118E-3</c:v>
                  </c:pt>
                  <c:pt idx="5">
                    <c:v>2.4196580454357835E-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S$210:$X$210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211:$X$211</c:f>
              <c:numCache>
                <c:formatCode>General</c:formatCode>
                <c:ptCount val="6"/>
                <c:pt idx="0">
                  <c:v>1.0079180431527806</c:v>
                </c:pt>
                <c:pt idx="1">
                  <c:v>0.28007468762732463</c:v>
                </c:pt>
                <c:pt idx="2">
                  <c:v>0.55671493671958161</c:v>
                </c:pt>
                <c:pt idx="3">
                  <c:v>3.4501284208591144E-2</c:v>
                </c:pt>
                <c:pt idx="4">
                  <c:v>1.6925237327837971E-2</c:v>
                </c:pt>
                <c:pt idx="5">
                  <c:v>7.778564850682304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52-4995-941B-D43C79057F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668272"/>
        <c:axId val="1734667856"/>
      </c:barChart>
      <c:lineChart>
        <c:grouping val="standard"/>
        <c:varyColors val="0"/>
        <c:ser>
          <c:idx val="1"/>
          <c:order val="1"/>
          <c:tx>
            <c:strRef>
              <c:f>Sheet1!$R$212</c:f>
              <c:strCache>
                <c:ptCount val="1"/>
                <c:pt idx="0">
                  <c:v>RNA-seq</c:v>
                </c:pt>
              </c:strCache>
            </c:strRef>
          </c:tx>
          <c:spPr>
            <a:ln w="19050" cap="rnd">
              <a:solidFill>
                <a:srgbClr val="FF3300"/>
              </a:solidFill>
              <a:round/>
            </a:ln>
            <a:effectLst/>
          </c:spPr>
          <c:marker>
            <c:symbol val="none"/>
          </c:marker>
          <c:cat>
            <c:strRef>
              <c:f>Sheet1!$S$210:$X$210</c:f>
              <c:strCache>
                <c:ptCount val="6"/>
                <c:pt idx="0">
                  <c:v>L 0h</c:v>
                </c:pt>
                <c:pt idx="1">
                  <c:v>L 3h</c:v>
                </c:pt>
                <c:pt idx="2">
                  <c:v>L 24h</c:v>
                </c:pt>
                <c:pt idx="3">
                  <c:v>R 0h</c:v>
                </c:pt>
                <c:pt idx="4">
                  <c:v>R 3h</c:v>
                </c:pt>
                <c:pt idx="5">
                  <c:v>R 24h</c:v>
                </c:pt>
              </c:strCache>
            </c:strRef>
          </c:cat>
          <c:val>
            <c:numRef>
              <c:f>Sheet1!$S$212:$X$212</c:f>
              <c:numCache>
                <c:formatCode>General</c:formatCode>
                <c:ptCount val="6"/>
                <c:pt idx="0">
                  <c:v>8.043333333333333</c:v>
                </c:pt>
                <c:pt idx="1">
                  <c:v>4.0933333333333328</c:v>
                </c:pt>
                <c:pt idx="2">
                  <c:v>6.64</c:v>
                </c:pt>
                <c:pt idx="3">
                  <c:v>1.2133333333333334</c:v>
                </c:pt>
                <c:pt idx="4">
                  <c:v>0.59333333333333327</c:v>
                </c:pt>
                <c:pt idx="5">
                  <c:v>0.199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052-4995-941B-D43C79057F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34677840"/>
        <c:axId val="1734654544"/>
      </c:lineChart>
      <c:catAx>
        <c:axId val="1734668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67856"/>
        <c:crosses val="autoZero"/>
        <c:auto val="1"/>
        <c:lblAlgn val="ctr"/>
        <c:lblOffset val="100"/>
        <c:noMultiLvlLbl val="0"/>
      </c:catAx>
      <c:valAx>
        <c:axId val="173466785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68272"/>
        <c:crosses val="autoZero"/>
        <c:crossBetween val="between"/>
      </c:valAx>
      <c:valAx>
        <c:axId val="1734654544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734677840"/>
        <c:crosses val="max"/>
        <c:crossBetween val="between"/>
      </c:valAx>
      <c:catAx>
        <c:axId val="17346778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3465454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24AF9B-E185-4247-BB4B-01C8980FF0EB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FFA1B0-D1A1-4F21-914B-CA59075F06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00105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A83B00-3672-4669-AC24-CA0342BE3FF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448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FFA1B0-D1A1-4F21-914B-CA59075F0634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30723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17600" y="696913"/>
            <a:ext cx="4646613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1030031">
              <a:defRPr/>
            </a:pPr>
            <a:endParaRPr lang="en-US" dirty="0"/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A83B00-3672-4669-AC24-CA0342BE3FF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20209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17600" y="696913"/>
            <a:ext cx="4646613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1030031">
              <a:defRPr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A83B00-3672-4669-AC24-CA0342BE3FF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1644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3725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0282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1461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571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34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0954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377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269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2198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3523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9069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DF912-702D-4AD7-B0A7-3F3AC0DA9B84}" type="datetimeFigureOut">
              <a:rPr lang="zh-CN" altLang="en-US" smtClean="0"/>
              <a:t>2019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54CC45-1D17-46D4-BFB3-6A3DE668C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6621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notesSlide" Target="../notesSlides/notesSlide2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3540048"/>
              </p:ext>
            </p:extLst>
          </p:nvPr>
        </p:nvGraphicFramePr>
        <p:xfrm>
          <a:off x="1427233" y="1001572"/>
          <a:ext cx="5722015" cy="3940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矩形 4"/>
          <p:cNvSpPr/>
          <p:nvPr/>
        </p:nvSpPr>
        <p:spPr>
          <a:xfrm>
            <a:off x="561474" y="5470357"/>
            <a:ext cx="803709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rrelation between qRT-PCR and RNA sequencing for the 15 selected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. Data was log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formed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5945954" y="3697744"/>
            <a:ext cx="81144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 = 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442</a:t>
            </a:r>
            <a:endParaRPr lang="en-US" altLang="zh-CN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02 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5839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/>
          <p:cNvGrpSpPr/>
          <p:nvPr/>
        </p:nvGrpSpPr>
        <p:grpSpPr>
          <a:xfrm>
            <a:off x="109901" y="18419"/>
            <a:ext cx="8935365" cy="6516250"/>
            <a:chOff x="109901" y="82217"/>
            <a:chExt cx="8935365" cy="6516250"/>
          </a:xfrm>
        </p:grpSpPr>
        <p:graphicFrame>
          <p:nvGraphicFramePr>
            <p:cNvPr id="4" name="图表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46251535"/>
                </p:ext>
              </p:extLst>
            </p:nvPr>
          </p:nvGraphicFramePr>
          <p:xfrm>
            <a:off x="138007" y="247476"/>
            <a:ext cx="1980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图表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53144557"/>
                </p:ext>
              </p:extLst>
            </p:nvPr>
          </p:nvGraphicFramePr>
          <p:xfrm>
            <a:off x="2378722" y="248574"/>
            <a:ext cx="1980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" name="图表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50977184"/>
                </p:ext>
              </p:extLst>
            </p:nvPr>
          </p:nvGraphicFramePr>
          <p:xfrm>
            <a:off x="4620430" y="251530"/>
            <a:ext cx="2089077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7" name="图表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00290362"/>
                </p:ext>
              </p:extLst>
            </p:nvPr>
          </p:nvGraphicFramePr>
          <p:xfrm>
            <a:off x="6943783" y="250020"/>
            <a:ext cx="2088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8" name="图表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62935572"/>
                </p:ext>
              </p:extLst>
            </p:nvPr>
          </p:nvGraphicFramePr>
          <p:xfrm>
            <a:off x="197450" y="1908749"/>
            <a:ext cx="2088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9" name="图表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96793956"/>
                </p:ext>
              </p:extLst>
            </p:nvPr>
          </p:nvGraphicFramePr>
          <p:xfrm>
            <a:off x="2356844" y="1905023"/>
            <a:ext cx="2088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10" name="图表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96513668"/>
                </p:ext>
              </p:extLst>
            </p:nvPr>
          </p:nvGraphicFramePr>
          <p:xfrm>
            <a:off x="4646007" y="1908222"/>
            <a:ext cx="2052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1" name="图表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49180037"/>
                </p:ext>
              </p:extLst>
            </p:nvPr>
          </p:nvGraphicFramePr>
          <p:xfrm>
            <a:off x="6921266" y="1908226"/>
            <a:ext cx="2124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12" name="图表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50538014"/>
                </p:ext>
              </p:extLst>
            </p:nvPr>
          </p:nvGraphicFramePr>
          <p:xfrm>
            <a:off x="137939" y="3577007"/>
            <a:ext cx="2088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13" name="矩形 12"/>
            <p:cNvSpPr/>
            <p:nvPr/>
          </p:nvSpPr>
          <p:spPr>
            <a:xfrm>
              <a:off x="457693" y="82217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50367_c2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2688140" y="83541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67045_c0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4941919" y="84869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75175_c0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>
              <a:off x="7248863" y="92490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76383_c0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>
              <a:off x="400645" y="1744443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78631_c1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>
              <a:off x="2643791" y="1745771"/>
              <a:ext cx="148309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90051_c6_g1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>
              <a:off x="4900007" y="1737403"/>
              <a:ext cx="153439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98215_c15_g24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7261886" y="1738727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95303_c0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418366" y="3399835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83339_c1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2" name="图表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5650029"/>
                </p:ext>
              </p:extLst>
            </p:nvPr>
          </p:nvGraphicFramePr>
          <p:xfrm>
            <a:off x="2377342" y="3573389"/>
            <a:ext cx="2052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23" name="图表 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30900730"/>
                </p:ext>
              </p:extLst>
            </p:nvPr>
          </p:nvGraphicFramePr>
          <p:xfrm>
            <a:off x="4643739" y="3576572"/>
            <a:ext cx="2088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aphicFrame>
          <p:nvGraphicFramePr>
            <p:cNvPr id="24" name="图表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3545242"/>
                </p:ext>
              </p:extLst>
            </p:nvPr>
          </p:nvGraphicFramePr>
          <p:xfrm>
            <a:off x="6920457" y="3576275"/>
            <a:ext cx="2124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25" name="矩形 24"/>
            <p:cNvSpPr/>
            <p:nvPr/>
          </p:nvSpPr>
          <p:spPr>
            <a:xfrm>
              <a:off x="2684349" y="3414309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96020_c1_g4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>
              <a:off x="4944330" y="3415633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79875_c1_g2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>
              <a:off x="7249207" y="3416961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95792_c0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8" name="图表 2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98995173"/>
                </p:ext>
              </p:extLst>
            </p:nvPr>
          </p:nvGraphicFramePr>
          <p:xfrm>
            <a:off x="109901" y="5230467"/>
            <a:ext cx="2088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aphicFrame>
          <p:nvGraphicFramePr>
            <p:cNvPr id="29" name="图表 2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88694400"/>
                </p:ext>
              </p:extLst>
            </p:nvPr>
          </p:nvGraphicFramePr>
          <p:xfrm>
            <a:off x="2391402" y="5228594"/>
            <a:ext cx="2088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graphicFrame>
          <p:nvGraphicFramePr>
            <p:cNvPr id="30" name="图表 2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59103588"/>
                </p:ext>
              </p:extLst>
            </p:nvPr>
          </p:nvGraphicFramePr>
          <p:xfrm>
            <a:off x="4617206" y="5226708"/>
            <a:ext cx="2088000" cy="13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sp>
          <p:nvSpPr>
            <p:cNvPr id="31" name="矩形 30"/>
            <p:cNvSpPr/>
            <p:nvPr/>
          </p:nvSpPr>
          <p:spPr>
            <a:xfrm>
              <a:off x="428142" y="5053095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89673_c0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>
              <a:off x="2681922" y="5054419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278846_c1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>
              <a:off x="4939835" y="5055747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INITY_DN193494_c0_g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0" name="矩形 59"/>
          <p:cNvSpPr/>
          <p:nvPr/>
        </p:nvSpPr>
        <p:spPr>
          <a:xfrm>
            <a:off x="6811112" y="4947240"/>
            <a:ext cx="230099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Expression of the selected 15 genes inferred at T0, T3 and T24 by RNA-</a:t>
            </a:r>
            <a:r>
              <a:rPr lang="en-US" altLang="zh-CN" sz="1200" b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b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L and R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 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ves and roots, respectively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and black </a:t>
            </a:r>
            <a:r>
              <a:rPr lang="zh-CN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umn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-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 and qPCR data, respectively.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represent standard deviation (n = 3)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1796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Rectangle 33"/>
          <p:cNvSpPr/>
          <p:nvPr/>
        </p:nvSpPr>
        <p:spPr>
          <a:xfrm>
            <a:off x="837212" y="5698188"/>
            <a:ext cx="1651414" cy="2840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</a:t>
            </a:r>
            <a:r>
              <a:rPr lang="en-US" altLang="zh-CN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  <a:endParaRPr lang="en-US" sz="12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26716" y="88992"/>
            <a:ext cx="9076829" cy="6178271"/>
            <a:chOff x="-908259" y="1556882"/>
            <a:chExt cx="8331905" cy="5952012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61852" y="1754783"/>
              <a:ext cx="4161794" cy="2774531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08259" y="1754099"/>
              <a:ext cx="4161796" cy="2774531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628905" y="1580215"/>
              <a:ext cx="1219241" cy="26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T3 vs. LT24 GO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84589" y="4946678"/>
              <a:ext cx="3745621" cy="2497083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555097" y="4724813"/>
              <a:ext cx="1423772" cy="26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T3 vs. LT24 KEGG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56282" y="4942447"/>
              <a:ext cx="3849676" cy="2566447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4767475" y="1577634"/>
              <a:ext cx="1219241" cy="26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T0 vs. LT24 GO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711630" y="4726632"/>
              <a:ext cx="1423772" cy="26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T0 vs. LT24 KEGG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8"/>
            <p:cNvSpPr txBox="1"/>
            <p:nvPr/>
          </p:nvSpPr>
          <p:spPr>
            <a:xfrm>
              <a:off x="-665144" y="1559715"/>
              <a:ext cx="334312" cy="26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  <p:sp>
          <p:nvSpPr>
            <p:cNvPr id="15" name="TextBox 19"/>
            <p:cNvSpPr txBox="1"/>
            <p:nvPr/>
          </p:nvSpPr>
          <p:spPr>
            <a:xfrm>
              <a:off x="3372200" y="1556882"/>
              <a:ext cx="341670" cy="26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</a:p>
          </p:txBody>
        </p:sp>
        <p:sp>
          <p:nvSpPr>
            <p:cNvPr id="16" name="TextBox 18"/>
            <p:cNvSpPr txBox="1"/>
            <p:nvPr/>
          </p:nvSpPr>
          <p:spPr>
            <a:xfrm>
              <a:off x="-659051" y="4674763"/>
              <a:ext cx="326956" cy="26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17" name="TextBox 19"/>
            <p:cNvSpPr txBox="1"/>
            <p:nvPr/>
          </p:nvSpPr>
          <p:spPr>
            <a:xfrm>
              <a:off x="3378296" y="4671925"/>
              <a:ext cx="341670" cy="26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</p:grpSp>
      <p:sp>
        <p:nvSpPr>
          <p:cNvPr id="4" name="矩形 3"/>
          <p:cNvSpPr/>
          <p:nvPr/>
        </p:nvSpPr>
        <p:spPr>
          <a:xfrm>
            <a:off x="311285" y="6317965"/>
            <a:ext cx="855846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b="1" kern="1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3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and KEGG enrichment analysis of all DEGs following CdCl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 at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0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3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leaves. 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72999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78413" y="94579"/>
            <a:ext cx="8980371" cy="6055629"/>
            <a:chOff x="279218" y="3577660"/>
            <a:chExt cx="6827176" cy="4603699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4681" y="3733208"/>
              <a:ext cx="3402002" cy="22680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1607476" y="3582308"/>
              <a:ext cx="1035224" cy="210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3 vs. RT24 GO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9218" y="3735678"/>
              <a:ext cx="3402000" cy="22680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1627" y="6261358"/>
              <a:ext cx="2880000" cy="1920001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1530145" y="6112001"/>
              <a:ext cx="1204617" cy="210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3 vs. RT24 KEGG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8394" y="6283569"/>
              <a:ext cx="2808000" cy="1872001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4866451" y="3584326"/>
              <a:ext cx="1035224" cy="210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0 vs. RT24 GO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731845" y="6107505"/>
              <a:ext cx="1204617" cy="210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0 vs. RT24 KEGG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8"/>
            <p:cNvSpPr txBox="1"/>
            <p:nvPr/>
          </p:nvSpPr>
          <p:spPr>
            <a:xfrm>
              <a:off x="317747" y="3580487"/>
              <a:ext cx="276878" cy="210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  <p:sp>
          <p:nvSpPr>
            <p:cNvPr id="12" name="TextBox 19"/>
            <p:cNvSpPr txBox="1"/>
            <p:nvPr/>
          </p:nvSpPr>
          <p:spPr>
            <a:xfrm>
              <a:off x="3661499" y="3577660"/>
              <a:ext cx="282972" cy="210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</a:p>
          </p:txBody>
        </p:sp>
        <p:sp>
          <p:nvSpPr>
            <p:cNvPr id="13" name="TextBox 18"/>
            <p:cNvSpPr txBox="1"/>
            <p:nvPr/>
          </p:nvSpPr>
          <p:spPr>
            <a:xfrm>
              <a:off x="323842" y="6089215"/>
              <a:ext cx="270786" cy="210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14" name="TextBox 19"/>
            <p:cNvSpPr txBox="1"/>
            <p:nvPr/>
          </p:nvSpPr>
          <p:spPr>
            <a:xfrm>
              <a:off x="3667596" y="6086374"/>
              <a:ext cx="282972" cy="2105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</p:grpSp>
      <p:sp>
        <p:nvSpPr>
          <p:cNvPr id="17" name="矩形 16"/>
          <p:cNvSpPr/>
          <p:nvPr/>
        </p:nvSpPr>
        <p:spPr>
          <a:xfrm>
            <a:off x="311285" y="6317965"/>
            <a:ext cx="855846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b="1" kern="1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4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and KEGG enrichment analysis of all DEGs following CdCl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 at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 vs. T0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 vs. T3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ot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403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8</TotalTime>
  <Words>228</Words>
  <Application>Microsoft Office PowerPoint</Application>
  <PresentationFormat>全屏显示(4:3)</PresentationFormat>
  <Paragraphs>44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1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unming zhao</dc:creator>
  <cp:lastModifiedBy>j</cp:lastModifiedBy>
  <cp:revision>17</cp:revision>
  <dcterms:created xsi:type="dcterms:W3CDTF">2019-01-23T13:20:39Z</dcterms:created>
  <dcterms:modified xsi:type="dcterms:W3CDTF">2019-05-17T03:12:36Z</dcterms:modified>
</cp:coreProperties>
</file>